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6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BFFF"/>
    <a:srgbClr val="00B2EE"/>
    <a:srgbClr val="E26714"/>
    <a:srgbClr val="C39B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93D81CF-94F2-401A-BA57-92F5A7B2D0C5}" styleName="보통 스타일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>
        <p:scale>
          <a:sx n="200" d="100"/>
          <a:sy n="200" d="100"/>
        </p:scale>
        <p:origin x="336" y="-654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5E225E-72F0-4853-92EE-6FDCB98569E6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C97A42-A716-4F81-9DB1-CE1E91B500B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7540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1pPr>
    <a:lvl2pPr marL="404440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2pPr>
    <a:lvl3pPr marL="808879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3pPr>
    <a:lvl4pPr marL="1213319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4pPr>
    <a:lvl5pPr marL="1617758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5pPr>
    <a:lvl6pPr marL="2022198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6pPr>
    <a:lvl7pPr marL="2426637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7pPr>
    <a:lvl8pPr marL="2831076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8pPr>
    <a:lvl9pPr marL="3235516" algn="l" defTabSz="808879" rtl="0" eaLnBrk="1" latinLnBrk="1" hangingPunct="1">
      <a:defRPr sz="106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8289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53284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0726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3505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1201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49105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4226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09149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45101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2725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1605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E4C1C-0111-43E8-8E5A-A54D6018375F}" type="datetimeFigureOut">
              <a:rPr lang="ko-KR" altLang="en-US" smtClean="0"/>
              <a:t>2021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9427CB-141F-4B2E-8803-A93466D97E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3070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66"/>
          <p:cNvSpPr txBox="1"/>
          <p:nvPr/>
        </p:nvSpPr>
        <p:spPr>
          <a:xfrm>
            <a:off x="413859" y="6743861"/>
            <a:ext cx="604070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arison of the expression levels of </a:t>
            </a:r>
            <a:r>
              <a:rPr lang="en-US" altLang="ko-KR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GFR3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tween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P and non-EP subgroups in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on-muscle invasive bladder cancer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atient cohorts.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levels of </a:t>
            </a:r>
            <a:r>
              <a:rPr lang="en-US" altLang="ko-KR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GFR3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P subgroup were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ly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gher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an in the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EP subgroup across CBNU (A), UROMOL (B), and European (C) cohorts. </a:t>
            </a:r>
            <a:r>
              <a:rPr lang="en-US" altLang="ko-KR" sz="1000" i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0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values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obtained by two-sample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-tests. EP, equivocal prognosis.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NU,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ungbuk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tional University Hospital.</a:t>
            </a:r>
            <a:endParaRPr lang="en-US" altLang="ko-KR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1141589" y="2162470"/>
            <a:ext cx="9909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BNU cohort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3005925" y="2162468"/>
            <a:ext cx="11897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ROMOL cohort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4951416" y="2155354"/>
            <a:ext cx="12089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uropean cohort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2099" y="2369129"/>
            <a:ext cx="1588905" cy="2696013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 rot="16200000">
            <a:off x="-595993" y="3517079"/>
            <a:ext cx="22974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dian-centered expression levels</a:t>
            </a:r>
          </a:p>
          <a:p>
            <a:pPr algn="ctr"/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log2 transformed scale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6200000">
            <a:off x="-372111" y="3410120"/>
            <a:ext cx="23552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5.0                   -2.5                      0   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168666" y="5012756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697547" y="5012756"/>
            <a:ext cx="6479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n-E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66820" y="2369128"/>
            <a:ext cx="1667961" cy="2696013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 rot="16200000">
            <a:off x="1518602" y="3779783"/>
            <a:ext cx="23552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-6               -4              -2                0               2  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059379" y="5012756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588260" y="5012756"/>
            <a:ext cx="6479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n-E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40597" y="2369128"/>
            <a:ext cx="1630625" cy="2696013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 rot="16200000">
            <a:off x="3335781" y="3609413"/>
            <a:ext cx="26960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-2            -1             0             </a:t>
            </a:r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2             3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053279" y="5012756"/>
            <a:ext cx="3545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582160" y="5012756"/>
            <a:ext cx="6479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n-E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49280" y="1837335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592380" y="1837335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548180" y="1837335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535675" y="2317377"/>
            <a:ext cx="10150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= 3.47 x 10</a:t>
            </a:r>
            <a:r>
              <a:rPr lang="en-US" altLang="ko-KR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5</a:t>
            </a:r>
            <a:endParaRPr lang="ko-KR" alt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527684" y="2317377"/>
            <a:ext cx="9989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= 5.2 x 10</a:t>
            </a:r>
            <a:r>
              <a:rPr lang="en-US" altLang="ko-KR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20</a:t>
            </a:r>
            <a:endParaRPr lang="ko-KR" alt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503663" y="2317377"/>
            <a:ext cx="9509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= 4.2 x 10</a:t>
            </a:r>
            <a:r>
              <a:rPr lang="en-US" altLang="ko-KR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6</a:t>
            </a:r>
            <a:endParaRPr lang="ko-KR" altLang="en-U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57497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96</TotalTime>
  <Words>136</Words>
  <Application>Microsoft Office PowerPoint</Application>
  <PresentationFormat>A4 용지(210x297mm)</PresentationFormat>
  <Paragraphs>2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eon-Kyu Kim</dc:creator>
  <cp:lastModifiedBy>Seon-Kyu Kim</cp:lastModifiedBy>
  <cp:revision>1840</cp:revision>
  <dcterms:created xsi:type="dcterms:W3CDTF">2018-02-19T05:53:37Z</dcterms:created>
  <dcterms:modified xsi:type="dcterms:W3CDTF">2021-01-21T05:59:15Z</dcterms:modified>
</cp:coreProperties>
</file>